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67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452CA-939F-42E6-ADC2-2F70A7E32C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01ECAF-D8C6-4152-B96C-8C0B290B4A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B1D8BF-0CE3-4C0E-851B-EBBDDB6B7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D06D00-5F65-4406-BC2B-DFC616213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12232A-545F-4DE4-98E9-1337C6DE0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960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C3BA6-6AD9-40FC-9AE8-AEDE51FE2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AEA2CD-0955-4521-BFC2-DEA8DD3EE6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E5FAA-6214-4ABB-9EB5-2680A8914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BEF763-0A9B-4E17-99E4-6C96B178A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7B2F6-8F24-453F-A6A9-ED0EB2CE3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638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D92847-7A74-4258-AEB2-74E0DB3051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399746-0051-411E-972B-4874EB66AB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BDADF-2A82-474A-AD86-422D3635D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EE0E9A-A5FE-423C-9957-A163A12FE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B1E901-B37D-4214-B5FB-C93BC8F94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007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15A262-A4C6-4A69-AA95-2E52ADED30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0890B4-DF15-4965-BB90-C2DD0F52E9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539EB0-EB0B-48D5-9581-72CBD535D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026672-CF61-47DF-BC7C-684058D7B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3D2048-13FA-4ABC-BC45-CE8CD8E99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201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7B5D3-8539-485B-A826-011B600665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C21AB2-F0C6-47DC-99CD-53FD74631C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BC28D5-D73F-4221-BBD8-52BA9E7F3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483746-BB79-4C72-9C2C-E5D2A83CD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43C6BD-42A3-429A-897E-0958CB7BD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401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5D51BB-E49B-40BF-9D0E-DC31AA0EEC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8ED405-7BE0-4A93-87A7-BC4FA22B2B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E3BE3B-C6A5-455E-92E0-1DCDAEDD9E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3426A3-720C-4793-93CA-671D55C0E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F183BF-2856-4350-B02F-B3F7E7DAF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D02F72-6601-484A-9867-38F37AAAB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393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26C463-584D-4835-8CF8-5E9E701161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6BC180-14C7-422A-B0B9-4046A170B3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03A829-2DF2-40E1-9CB4-0647554E9F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49F280-119A-4CB5-8480-78300C1B68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9FF7CC-0656-40AA-8D23-8947D4A4CB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8DC2C07-D328-4D16-889A-A12C611B3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8A6FBF-DC85-4BD2-8680-61B120BE5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275C58-FA7E-460C-BE7B-F249BCA66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496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57F85-12B3-43B5-935C-66AE07D3C3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784B01-4EF5-4893-A48B-35578CFB9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CB10E2-F413-4DB7-8C77-B3B3999A7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FA7D77-ED58-4D4A-B5DA-A11030615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474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1A9AFB-9AD4-421C-9582-7CB784D24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73CB2C0-05BF-4A5C-AD7D-B80EF3A8D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B82007-A879-4F31-B795-C778CAA4C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475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87C18-06D0-499C-834A-B45CACCD0B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BE6B95-20E1-480D-932A-684C47BFDE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607872-FBBC-4F53-AA34-0AE057A5A4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198FC9-C9F0-49BB-9F0D-57F52B63D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0F0093-B1F9-444B-8E52-4B6EE58F1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EDE135-BE02-4424-8E26-C269124F5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11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6D665-F444-4E09-AFD9-43B5EA431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2AEFB9-E9DE-4F78-9ECB-573B317995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67A46C-0E03-43A9-B26B-5442C0F0F7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422DC6-1F8C-41D5-8984-B0FBB629F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F3AED7-4D05-4153-AD00-5723E64D7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C103B2-6637-4F70-9D45-0136EC4C2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459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A96138-1922-4862-9DF4-D0C032D0B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0FFFD3-73DB-4A90-B51B-E4811DF224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EB7398-3672-4F96-9513-06A627F9F80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42E9CB-5FD9-4310-9A19-C99AEDA0BF36}" type="datetimeFigureOut">
              <a:rPr lang="en-US" smtClean="0"/>
              <a:t>1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4AD15B-DA9E-41B1-9068-576C8E5BC9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6E1280-091A-431E-8943-73161ED8A7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40553-09A9-491A-92FD-F1138CBA54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302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F1394148-9AA0-4B3D-8850-AC45700631D7}"/>
              </a:ext>
            </a:extLst>
          </p:cNvPr>
          <p:cNvSpPr>
            <a:spLocks/>
          </p:cNvSpPr>
          <p:nvPr/>
        </p:nvSpPr>
        <p:spPr bwMode="auto">
          <a:xfrm>
            <a:off x="3390902" y="446089"/>
            <a:ext cx="2228850" cy="68262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ecords identified through database searching</a:t>
            </a:r>
            <a:b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n = 90)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AutoShape 18">
            <a:extLst>
              <a:ext uri="{FF2B5EF4-FFF2-40B4-BE49-F238E27FC236}">
                <a16:creationId xmlns:a16="http://schemas.microsoft.com/office/drawing/2014/main" id="{3DF8BBDE-3BEA-4891-87B7-AB789CF2A37E}"/>
              </a:ext>
            </a:extLst>
          </p:cNvPr>
          <p:cNvSpPr>
            <a:spLocks/>
          </p:cNvSpPr>
          <p:nvPr/>
        </p:nvSpPr>
        <p:spPr bwMode="auto">
          <a:xfrm rot="-5400000">
            <a:off x="2256634" y="2345532"/>
            <a:ext cx="1371600" cy="296863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reening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AutoShape 20">
            <a:extLst>
              <a:ext uri="{FF2B5EF4-FFF2-40B4-BE49-F238E27FC236}">
                <a16:creationId xmlns:a16="http://schemas.microsoft.com/office/drawing/2014/main" id="{71D4C62B-D16C-4B4C-BFA0-189A05967BDA}"/>
              </a:ext>
            </a:extLst>
          </p:cNvPr>
          <p:cNvSpPr>
            <a:spLocks/>
          </p:cNvSpPr>
          <p:nvPr/>
        </p:nvSpPr>
        <p:spPr bwMode="auto">
          <a:xfrm rot="-5400000">
            <a:off x="2237584" y="5482432"/>
            <a:ext cx="1371600" cy="296863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cluded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AutoShape 19">
            <a:extLst>
              <a:ext uri="{FF2B5EF4-FFF2-40B4-BE49-F238E27FC236}">
                <a16:creationId xmlns:a16="http://schemas.microsoft.com/office/drawing/2014/main" id="{EB2E4DCA-6DA1-4BB1-960D-D61C7717C12C}"/>
              </a:ext>
            </a:extLst>
          </p:cNvPr>
          <p:cNvSpPr>
            <a:spLocks/>
          </p:cNvSpPr>
          <p:nvPr/>
        </p:nvSpPr>
        <p:spPr bwMode="auto">
          <a:xfrm rot="-5400000">
            <a:off x="2240759" y="3882232"/>
            <a:ext cx="1371600" cy="296863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ligibility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8" name="AutoShape 5">
            <a:extLst>
              <a:ext uri="{FF2B5EF4-FFF2-40B4-BE49-F238E27FC236}">
                <a16:creationId xmlns:a16="http://schemas.microsoft.com/office/drawing/2014/main" id="{4476885F-DDEC-4931-A52E-AC3DD1841D4C}"/>
              </a:ext>
            </a:extLst>
          </p:cNvPr>
          <p:cNvCxnSpPr>
            <a:cxnSpLocks/>
          </p:cNvCxnSpPr>
          <p:nvPr/>
        </p:nvCxnSpPr>
        <p:spPr bwMode="auto">
          <a:xfrm>
            <a:off x="4521202" y="1163639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9" name="AutoShape 6">
            <a:extLst>
              <a:ext uri="{FF2B5EF4-FFF2-40B4-BE49-F238E27FC236}">
                <a16:creationId xmlns:a16="http://schemas.microsoft.com/office/drawing/2014/main" id="{FB8BBD4F-9BFE-45A6-AD50-42FF4586FDEA}"/>
              </a:ext>
            </a:extLst>
          </p:cNvPr>
          <p:cNvCxnSpPr>
            <a:cxnSpLocks/>
          </p:cNvCxnSpPr>
          <p:nvPr/>
        </p:nvCxnSpPr>
        <p:spPr bwMode="auto">
          <a:xfrm>
            <a:off x="6667502" y="1169989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10" name="AutoShape 17">
            <a:extLst>
              <a:ext uri="{FF2B5EF4-FFF2-40B4-BE49-F238E27FC236}">
                <a16:creationId xmlns:a16="http://schemas.microsoft.com/office/drawing/2014/main" id="{0C663863-DBEE-4FCE-B9CF-56F4F9390824}"/>
              </a:ext>
            </a:extLst>
          </p:cNvPr>
          <p:cNvSpPr>
            <a:spLocks/>
          </p:cNvSpPr>
          <p:nvPr/>
        </p:nvSpPr>
        <p:spPr bwMode="auto">
          <a:xfrm rot="-5400000">
            <a:off x="2256634" y="786607"/>
            <a:ext cx="1371600" cy="296863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dentification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3">
            <a:extLst>
              <a:ext uri="{FF2B5EF4-FFF2-40B4-BE49-F238E27FC236}">
                <a16:creationId xmlns:a16="http://schemas.microsoft.com/office/drawing/2014/main" id="{24956FAF-EEEB-416A-B89B-A608F2460FB6}"/>
              </a:ext>
            </a:extLst>
          </p:cNvPr>
          <p:cNvSpPr>
            <a:spLocks/>
          </p:cNvSpPr>
          <p:nvPr/>
        </p:nvSpPr>
        <p:spPr bwMode="auto">
          <a:xfrm>
            <a:off x="5953127" y="442914"/>
            <a:ext cx="222885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dditional records identified through other sources</a:t>
            </a:r>
            <a:b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n = 5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4">
            <a:extLst>
              <a:ext uri="{FF2B5EF4-FFF2-40B4-BE49-F238E27FC236}">
                <a16:creationId xmlns:a16="http://schemas.microsoft.com/office/drawing/2014/main" id="{065E8AAB-F965-44FD-872F-2C6C5043851A}"/>
              </a:ext>
            </a:extLst>
          </p:cNvPr>
          <p:cNvSpPr>
            <a:spLocks/>
          </p:cNvSpPr>
          <p:nvPr/>
        </p:nvSpPr>
        <p:spPr bwMode="auto">
          <a:xfrm>
            <a:off x="4175127" y="1627189"/>
            <a:ext cx="2771775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ecords after duplicates removed</a:t>
            </a:r>
            <a:b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n = 95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9">
            <a:extLst>
              <a:ext uri="{FF2B5EF4-FFF2-40B4-BE49-F238E27FC236}">
                <a16:creationId xmlns:a16="http://schemas.microsoft.com/office/drawing/2014/main" id="{D1553876-F1E9-4E0E-9AC5-603C61946F08}"/>
              </a:ext>
            </a:extLst>
          </p:cNvPr>
          <p:cNvSpPr>
            <a:spLocks/>
          </p:cNvSpPr>
          <p:nvPr/>
        </p:nvSpPr>
        <p:spPr bwMode="auto">
          <a:xfrm>
            <a:off x="4708527" y="2682876"/>
            <a:ext cx="1760538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itles/abstracts screened</a:t>
            </a:r>
            <a:b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n = 95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14">
            <a:extLst>
              <a:ext uri="{FF2B5EF4-FFF2-40B4-BE49-F238E27FC236}">
                <a16:creationId xmlns:a16="http://schemas.microsoft.com/office/drawing/2014/main" id="{48F01915-8B42-4D4E-9CAF-71519EFADA5D}"/>
              </a:ext>
            </a:extLst>
          </p:cNvPr>
          <p:cNvSpPr>
            <a:spLocks/>
          </p:cNvSpPr>
          <p:nvPr/>
        </p:nvSpPr>
        <p:spPr bwMode="auto">
          <a:xfrm>
            <a:off x="7045327" y="2368551"/>
            <a:ext cx="2354263" cy="11461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ecords excluded: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omment (n = 1)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eview (n = 7)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eply (n = 4)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ot in English (n = 7)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Unrelated (n = 28)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1">
            <a:extLst>
              <a:ext uri="{FF2B5EF4-FFF2-40B4-BE49-F238E27FC236}">
                <a16:creationId xmlns:a16="http://schemas.microsoft.com/office/drawing/2014/main" id="{2B8027F9-EA3E-49DB-90BD-C6D20303A5AF}"/>
              </a:ext>
            </a:extLst>
          </p:cNvPr>
          <p:cNvSpPr>
            <a:spLocks/>
          </p:cNvSpPr>
          <p:nvPr/>
        </p:nvSpPr>
        <p:spPr bwMode="auto">
          <a:xfrm>
            <a:off x="4705352" y="3976689"/>
            <a:ext cx="171450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ull-text articles assessed for eligibility</a:t>
            </a:r>
            <a:b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n = 48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16">
            <a:extLst>
              <a:ext uri="{FF2B5EF4-FFF2-40B4-BE49-F238E27FC236}">
                <a16:creationId xmlns:a16="http://schemas.microsoft.com/office/drawing/2014/main" id="{6DDC0489-1811-4E20-B611-99481B893B0C}"/>
              </a:ext>
            </a:extLst>
          </p:cNvPr>
          <p:cNvSpPr>
            <a:spLocks/>
          </p:cNvSpPr>
          <p:nvPr/>
        </p:nvSpPr>
        <p:spPr bwMode="auto">
          <a:xfrm>
            <a:off x="7054852" y="4070351"/>
            <a:ext cx="2343150" cy="55721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ull-text articles excluded:</a:t>
            </a:r>
            <a:b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o PrecisionPoint cohort (n = 31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0">
            <a:extLst>
              <a:ext uri="{FF2B5EF4-FFF2-40B4-BE49-F238E27FC236}">
                <a16:creationId xmlns:a16="http://schemas.microsoft.com/office/drawing/2014/main" id="{1DC709D8-EACC-4EFA-97E6-C11EF5F5C970}"/>
              </a:ext>
            </a:extLst>
          </p:cNvPr>
          <p:cNvSpPr>
            <a:spLocks/>
          </p:cNvSpPr>
          <p:nvPr/>
        </p:nvSpPr>
        <p:spPr bwMode="auto">
          <a:xfrm>
            <a:off x="4705352" y="5405439"/>
            <a:ext cx="171450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tudies included in analysis</a:t>
            </a:r>
            <a:b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</a:b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n = 17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8" name="AutoShape 7">
            <a:extLst>
              <a:ext uri="{FF2B5EF4-FFF2-40B4-BE49-F238E27FC236}">
                <a16:creationId xmlns:a16="http://schemas.microsoft.com/office/drawing/2014/main" id="{F01BEF48-4D6D-4F75-B195-A0CA17F29104}"/>
              </a:ext>
            </a:extLst>
          </p:cNvPr>
          <p:cNvCxnSpPr>
            <a:cxnSpLocks/>
          </p:cNvCxnSpPr>
          <p:nvPr/>
        </p:nvCxnSpPr>
        <p:spPr bwMode="auto">
          <a:xfrm>
            <a:off x="5600702" y="2198689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19" name="AutoShape 12">
            <a:extLst>
              <a:ext uri="{FF2B5EF4-FFF2-40B4-BE49-F238E27FC236}">
                <a16:creationId xmlns:a16="http://schemas.microsoft.com/office/drawing/2014/main" id="{E42E9CCF-9314-4169-BEEB-1FDECE47B496}"/>
              </a:ext>
            </a:extLst>
          </p:cNvPr>
          <p:cNvCxnSpPr>
            <a:cxnSpLocks/>
          </p:cNvCxnSpPr>
          <p:nvPr/>
        </p:nvCxnSpPr>
        <p:spPr bwMode="auto">
          <a:xfrm>
            <a:off x="5634992" y="3254376"/>
            <a:ext cx="0" cy="67056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20" name="AutoShape 15">
            <a:extLst>
              <a:ext uri="{FF2B5EF4-FFF2-40B4-BE49-F238E27FC236}">
                <a16:creationId xmlns:a16="http://schemas.microsoft.com/office/drawing/2014/main" id="{D7CA5B82-D8AF-4DFA-B706-FCC09DBF920D}"/>
              </a:ext>
            </a:extLst>
          </p:cNvPr>
          <p:cNvCxnSpPr>
            <a:cxnSpLocks/>
          </p:cNvCxnSpPr>
          <p:nvPr/>
        </p:nvCxnSpPr>
        <p:spPr bwMode="auto">
          <a:xfrm>
            <a:off x="5634992" y="4662489"/>
            <a:ext cx="0" cy="74739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21" name="AutoShape 8">
            <a:extLst>
              <a:ext uri="{FF2B5EF4-FFF2-40B4-BE49-F238E27FC236}">
                <a16:creationId xmlns:a16="http://schemas.microsoft.com/office/drawing/2014/main" id="{42885A01-FA13-4C2F-8CFC-C556E6DF6E79}"/>
              </a:ext>
            </a:extLst>
          </p:cNvPr>
          <p:cNvCxnSpPr>
            <a:cxnSpLocks/>
          </p:cNvCxnSpPr>
          <p:nvPr/>
        </p:nvCxnSpPr>
        <p:spPr bwMode="auto">
          <a:xfrm>
            <a:off x="6476367" y="2997836"/>
            <a:ext cx="578485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22" name="AutoShape 13">
            <a:extLst>
              <a:ext uri="{FF2B5EF4-FFF2-40B4-BE49-F238E27FC236}">
                <a16:creationId xmlns:a16="http://schemas.microsoft.com/office/drawing/2014/main" id="{CB69CB9B-C9F5-40EC-B20D-2B904388CA50}"/>
              </a:ext>
            </a:extLst>
          </p:cNvPr>
          <p:cNvCxnSpPr>
            <a:cxnSpLocks/>
          </p:cNvCxnSpPr>
          <p:nvPr/>
        </p:nvCxnSpPr>
        <p:spPr bwMode="auto">
          <a:xfrm>
            <a:off x="6416677" y="4358641"/>
            <a:ext cx="628650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</p:spTree>
    <p:extLst>
      <p:ext uri="{BB962C8B-B14F-4D97-AF65-F5344CB8AC3E}">
        <p14:creationId xmlns:p14="http://schemas.microsoft.com/office/powerpoint/2010/main" val="1092396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orin</dc:creator>
  <cp:lastModifiedBy>Michael Gorin</cp:lastModifiedBy>
  <cp:revision>1</cp:revision>
  <dcterms:created xsi:type="dcterms:W3CDTF">2022-01-27T04:20:02Z</dcterms:created>
  <dcterms:modified xsi:type="dcterms:W3CDTF">2022-01-27T04:20:25Z</dcterms:modified>
</cp:coreProperties>
</file>